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48"/>
    <p:restoredTop sz="99220" autoAdjust="0"/>
  </p:normalViewPr>
  <p:slideViewPr>
    <p:cSldViewPr snapToGrid="0" snapToObjects="1">
      <p:cViewPr>
        <p:scale>
          <a:sx n="107" d="100"/>
          <a:sy n="107" d="100"/>
        </p:scale>
        <p:origin x="-992" y="-1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8346D5-E7D6-BE45-8912-011796BB3CA7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AA430-F9D3-3A4D-8865-F121C3184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157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jpg"/><Relationship Id="rId12" Type="http://schemas.openxmlformats.org/officeDocument/2006/relationships/image" Target="../media/image11.jp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/>
          <p:cNvSpPr txBox="1"/>
          <p:nvPr/>
        </p:nvSpPr>
        <p:spPr>
          <a:xfrm>
            <a:off x="6536285" y="6532976"/>
            <a:ext cx="2558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Annis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, Additional File: Fig. S3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152333" y="1957382"/>
            <a:ext cx="8842437" cy="2938072"/>
            <a:chOff x="152333" y="1423232"/>
            <a:chExt cx="8842437" cy="2938072"/>
          </a:xfrm>
        </p:grpSpPr>
        <p:grpSp>
          <p:nvGrpSpPr>
            <p:cNvPr id="17" name="Group 16"/>
            <p:cNvGrpSpPr/>
            <p:nvPr/>
          </p:nvGrpSpPr>
          <p:grpSpPr>
            <a:xfrm>
              <a:off x="3063064" y="1423232"/>
              <a:ext cx="5931706" cy="2847053"/>
              <a:chOff x="3063064" y="1423232"/>
              <a:chExt cx="5931706" cy="2847053"/>
            </a:xfrm>
          </p:grpSpPr>
          <p:sp>
            <p:nvSpPr>
              <p:cNvPr id="65" name="TextBox 64"/>
              <p:cNvSpPr txBox="1"/>
              <p:nvPr/>
            </p:nvSpPr>
            <p:spPr>
              <a:xfrm>
                <a:off x="5044888" y="1483464"/>
                <a:ext cx="9967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10 minute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6401200" y="1492717"/>
                <a:ext cx="9460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20 minute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7883461" y="1483464"/>
                <a:ext cx="9832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0 minute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 rot="16200000">
                <a:off x="2905512" y="2222964"/>
                <a:ext cx="639582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lastic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 rot="16200000">
                <a:off x="2708821" y="3525897"/>
                <a:ext cx="10329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Arial"/>
                    <a:cs typeface="Arial"/>
                  </a:rPr>
                  <a:t>Vitronect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grpSp>
            <p:nvGrpSpPr>
              <p:cNvPr id="41" name="Group 40"/>
              <p:cNvGrpSpPr/>
              <p:nvPr/>
            </p:nvGrpSpPr>
            <p:grpSpPr>
              <a:xfrm>
                <a:off x="3434917" y="1752934"/>
                <a:ext cx="5559853" cy="2517351"/>
                <a:chOff x="3192261" y="384810"/>
                <a:chExt cx="6416686" cy="2905302"/>
              </a:xfrm>
            </p:grpSpPr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1853" t="29684" r="-60" b="48068"/>
                <a:stretch/>
              </p:blipFill>
              <p:spPr>
                <a:xfrm>
                  <a:off x="3192261" y="384810"/>
                  <a:ext cx="1572364" cy="144665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9706" t="12304" r="22168" b="65586"/>
                <a:stretch/>
              </p:blipFill>
              <p:spPr>
                <a:xfrm>
                  <a:off x="4804463" y="384810"/>
                  <a:ext cx="1565333" cy="143771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254" t="32768" r="54454" b="45122"/>
                <a:stretch/>
              </p:blipFill>
              <p:spPr>
                <a:xfrm>
                  <a:off x="8029209" y="384810"/>
                  <a:ext cx="1579738" cy="143771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8" name="Picture 27"/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8214" t="24874" r="13651" b="53520"/>
                <a:stretch/>
              </p:blipFill>
              <p:spPr>
                <a:xfrm>
                  <a:off x="3192261" y="1885177"/>
                  <a:ext cx="1566122" cy="140493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9" name="Picture 28"/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118" t="29072" r="45900" b="49280"/>
                <a:stretch/>
              </p:blipFill>
              <p:spPr>
                <a:xfrm>
                  <a:off x="4812003" y="1882430"/>
                  <a:ext cx="1552898" cy="140768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2" name="Picture 31"/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094" t="54175" r="45614" b="24118"/>
                <a:stretch/>
              </p:blipFill>
              <p:spPr>
                <a:xfrm>
                  <a:off x="6418521" y="1878593"/>
                  <a:ext cx="1579736" cy="141151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4" name="Picture 33"/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077" t="76465" r="58937" b="1828"/>
                <a:stretch/>
              </p:blipFill>
              <p:spPr>
                <a:xfrm>
                  <a:off x="8051879" y="1878593"/>
                  <a:ext cx="1553321" cy="141151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860" t="36262" r="18950" b="41463"/>
                <a:stretch/>
              </p:blipFill>
              <p:spPr>
                <a:xfrm>
                  <a:off x="6418520" y="384810"/>
                  <a:ext cx="1570850" cy="144839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116" name="TextBox 115"/>
              <p:cNvSpPr txBox="1"/>
              <p:nvPr/>
            </p:nvSpPr>
            <p:spPr>
              <a:xfrm>
                <a:off x="3706522" y="1483464"/>
                <a:ext cx="8564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5 minute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8" name="Straight Connector 7"/>
              <p:cNvCxnSpPr/>
              <p:nvPr/>
            </p:nvCxnSpPr>
            <p:spPr>
              <a:xfrm flipV="1">
                <a:off x="8425096" y="4088056"/>
                <a:ext cx="441588" cy="2971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3063064" y="1423232"/>
                <a:ext cx="35573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 smtClean="0">
                    <a:latin typeface="Arial"/>
                    <a:cs typeface="Arial"/>
                  </a:rPr>
                  <a:t>B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152333" y="1423232"/>
              <a:ext cx="2721043" cy="2938072"/>
              <a:chOff x="128593" y="1423232"/>
              <a:chExt cx="2721043" cy="2938072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1789020" y="4084305"/>
                <a:ext cx="8503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α-Tubul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005781" y="3412129"/>
                <a:ext cx="629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FRA-1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1912416" y="2766699"/>
                <a:ext cx="7148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FRA-1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156873" y="3840943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5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42440" y="3158088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37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62988" y="2547265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37</a:t>
                </a:r>
              </a:p>
            </p:txBody>
          </p:sp>
          <p:cxnSp>
            <p:nvCxnSpPr>
              <p:cNvPr id="25" name="Straight Connector 24"/>
              <p:cNvCxnSpPr/>
              <p:nvPr/>
            </p:nvCxnSpPr>
            <p:spPr>
              <a:xfrm>
                <a:off x="412280" y="2680829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>
                <a:off x="412280" y="3303948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>
                <a:off x="412280" y="3988089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1906205" y="2215454"/>
                <a:ext cx="4205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20</a:t>
                </a:r>
                <a:endParaRPr lang="en-US" sz="1000" dirty="0" smtClean="0">
                  <a:latin typeface="Arial"/>
                  <a:cs typeface="Arial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144996" y="221545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30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674285" y="221545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10</a:t>
                </a:r>
                <a:endParaRPr lang="en-US" sz="1000" dirty="0" smtClean="0">
                  <a:latin typeface="Arial"/>
                  <a:cs typeface="Arial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997035" y="221545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20</a:t>
                </a:r>
                <a:endParaRPr lang="en-US" sz="1000" dirty="0" smtClean="0">
                  <a:latin typeface="Arial"/>
                  <a:cs typeface="Arial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1219711" y="221545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30</a:t>
                </a:r>
                <a:endParaRPr lang="en-US" sz="1000" dirty="0" smtClean="0">
                  <a:latin typeface="Arial"/>
                  <a:cs typeface="Arial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745566" y="221545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10</a:t>
                </a:r>
                <a:endParaRPr lang="en-US" sz="1000" dirty="0" smtClean="0">
                  <a:latin typeface="Arial"/>
                  <a:cs typeface="Arial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707522" y="1879353"/>
                <a:ext cx="637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lastic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495217" y="1879353"/>
                <a:ext cx="9217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/>
                    <a:cs typeface="Arial"/>
                  </a:rPr>
                  <a:t>Vitronectin</a:t>
                </a:r>
                <a:endParaRPr lang="en-US" sz="1200" dirty="0" smtClean="0">
                  <a:latin typeface="Arial"/>
                  <a:cs typeface="Arial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1187018" y="1492717"/>
                <a:ext cx="6807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BRC31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18" t="26896" r="12309" b="48633"/>
              <a:stretch/>
            </p:blipFill>
            <p:spPr>
              <a:xfrm>
                <a:off x="538823" y="2506692"/>
                <a:ext cx="1962366" cy="28821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87" name="TextBox 86"/>
              <p:cNvSpPr txBox="1"/>
              <p:nvPr/>
            </p:nvSpPr>
            <p:spPr>
              <a:xfrm>
                <a:off x="1484071" y="2215454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>
                    <a:latin typeface="Arial"/>
                    <a:cs typeface="Arial"/>
                  </a:rPr>
                  <a:t>5</a:t>
                </a:r>
                <a:endParaRPr lang="en-US" sz="1000" dirty="0" smtClean="0">
                  <a:latin typeface="Arial"/>
                  <a:cs typeface="Arial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543679" y="2215454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5</a:t>
                </a:r>
              </a:p>
            </p:txBody>
          </p:sp>
          <p:pic>
            <p:nvPicPr>
              <p:cNvPr id="30" name="Picture 29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933" t="44128" r="16902" b="32773"/>
              <a:stretch/>
            </p:blipFill>
            <p:spPr>
              <a:xfrm>
                <a:off x="550421" y="3152033"/>
                <a:ext cx="1950768" cy="30961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1" name="Picture 30"/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27" t="28653" r="16495" b="46870"/>
              <a:stretch/>
            </p:blipFill>
            <p:spPr>
              <a:xfrm>
                <a:off x="539685" y="3807384"/>
                <a:ext cx="1961504" cy="32258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130974" y="2328536"/>
                <a:ext cx="458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/>
                    <a:cs typeface="Arial"/>
                  </a:rPr>
                  <a:t>kDa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2422704" y="2209203"/>
                <a:ext cx="4269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min.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15" name="Straight Connector 14"/>
              <p:cNvCxnSpPr/>
              <p:nvPr/>
            </p:nvCxnSpPr>
            <p:spPr>
              <a:xfrm>
                <a:off x="1547018" y="2156104"/>
                <a:ext cx="8999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583638" y="2156104"/>
                <a:ext cx="8999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/>
              <p:cNvCxnSpPr/>
              <p:nvPr/>
            </p:nvCxnSpPr>
            <p:spPr>
              <a:xfrm>
                <a:off x="583634" y="1857444"/>
                <a:ext cx="1871989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>
                <a:off x="128593" y="1423232"/>
                <a:ext cx="37702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latin typeface="Arial"/>
                    <a:cs typeface="Arial"/>
                  </a:rPr>
                  <a:t>A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125119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8</TotalTime>
  <Words>49</Words>
  <Application>Microsoft Macintosh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G Annis, Dr</dc:creator>
  <cp:lastModifiedBy>Peter Siegel</cp:lastModifiedBy>
  <cp:revision>21</cp:revision>
  <dcterms:created xsi:type="dcterms:W3CDTF">2017-11-10T02:43:22Z</dcterms:created>
  <dcterms:modified xsi:type="dcterms:W3CDTF">2017-12-17T02:53:47Z</dcterms:modified>
</cp:coreProperties>
</file>